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21" d="100"/>
          <a:sy n="121" d="100"/>
        </p:scale>
        <p:origin x="-1744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EC2E0-9A0F-0E46-A0F7-30D07CC60228}" type="datetimeFigureOut">
              <a:rPr lang="it-IT" smtClean="0"/>
              <a:t>28/11/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F249A-2F1A-094F-A8DC-B42AB2BF21AE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24248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EC2E0-9A0F-0E46-A0F7-30D07CC60228}" type="datetimeFigureOut">
              <a:rPr lang="it-IT" smtClean="0"/>
              <a:t>28/11/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F249A-2F1A-094F-A8DC-B42AB2BF21AE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6826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EC2E0-9A0F-0E46-A0F7-30D07CC60228}" type="datetimeFigureOut">
              <a:rPr lang="it-IT" smtClean="0"/>
              <a:t>28/11/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F249A-2F1A-094F-A8DC-B42AB2BF21AE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50165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EC2E0-9A0F-0E46-A0F7-30D07CC60228}" type="datetimeFigureOut">
              <a:rPr lang="it-IT" smtClean="0"/>
              <a:t>28/11/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F249A-2F1A-094F-A8DC-B42AB2BF21AE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049350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EC2E0-9A0F-0E46-A0F7-30D07CC60228}" type="datetimeFigureOut">
              <a:rPr lang="it-IT" smtClean="0"/>
              <a:t>28/11/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F249A-2F1A-094F-A8DC-B42AB2BF21AE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363157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EC2E0-9A0F-0E46-A0F7-30D07CC60228}" type="datetimeFigureOut">
              <a:rPr lang="it-IT" smtClean="0"/>
              <a:t>28/11/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F249A-2F1A-094F-A8DC-B42AB2BF21AE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524582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EC2E0-9A0F-0E46-A0F7-30D07CC60228}" type="datetimeFigureOut">
              <a:rPr lang="it-IT" smtClean="0"/>
              <a:t>28/11/1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F249A-2F1A-094F-A8DC-B42AB2BF21AE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178459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EC2E0-9A0F-0E46-A0F7-30D07CC60228}" type="datetimeFigureOut">
              <a:rPr lang="it-IT" smtClean="0"/>
              <a:t>28/11/1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F249A-2F1A-094F-A8DC-B42AB2BF21AE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920565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EC2E0-9A0F-0E46-A0F7-30D07CC60228}" type="datetimeFigureOut">
              <a:rPr lang="it-IT" smtClean="0"/>
              <a:t>28/11/1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F249A-2F1A-094F-A8DC-B42AB2BF21AE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04550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EC2E0-9A0F-0E46-A0F7-30D07CC60228}" type="datetimeFigureOut">
              <a:rPr lang="it-IT" smtClean="0"/>
              <a:t>28/11/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F249A-2F1A-094F-A8DC-B42AB2BF21AE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58842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EC2E0-9A0F-0E46-A0F7-30D07CC60228}" type="datetimeFigureOut">
              <a:rPr lang="it-IT" smtClean="0"/>
              <a:t>28/11/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F249A-2F1A-094F-A8DC-B42AB2BF21AE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779229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9EC2E0-9A0F-0E46-A0F7-30D07CC60228}" type="datetimeFigureOut">
              <a:rPr lang="it-IT" smtClean="0"/>
              <a:t>28/11/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FF249A-2F1A-094F-A8DC-B42AB2BF21AE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047516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3" descr="Sel8 mod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08793" y="1384300"/>
            <a:ext cx="1993900" cy="2339975"/>
          </a:xfrm>
          <a:prstGeom prst="rect">
            <a:avLst/>
          </a:prstGeom>
          <a:noFill/>
          <a:ln w="25400">
            <a:solidFill>
              <a:schemeClr val="hlink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4" descr="Vesuvio2001 mod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57119" y="1384300"/>
            <a:ext cx="2146300" cy="2089150"/>
          </a:xfrm>
          <a:prstGeom prst="rect">
            <a:avLst/>
          </a:prstGeom>
          <a:noFill/>
          <a:ln w="25400">
            <a:solidFill>
              <a:schemeClr val="hlink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CasellaDiTesto 8"/>
          <p:cNvSpPr txBox="1"/>
          <p:nvPr/>
        </p:nvSpPr>
        <p:spPr>
          <a:xfrm>
            <a:off x="1899645" y="4083045"/>
            <a:ext cx="1640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a) San Marzano</a:t>
            </a:r>
            <a:endParaRPr lang="it-IT" dirty="0"/>
          </a:p>
        </p:txBody>
      </p:sp>
      <p:sp>
        <p:nvSpPr>
          <p:cNvPr id="10" name="Rettangolo 9"/>
          <p:cNvSpPr/>
          <p:nvPr/>
        </p:nvSpPr>
        <p:spPr>
          <a:xfrm>
            <a:off x="5557119" y="4094529"/>
            <a:ext cx="13963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/>
              <a:t>b) Vesuviano</a:t>
            </a:r>
            <a:endParaRPr lang="it-IT" dirty="0"/>
          </a:p>
        </p:txBody>
      </p:sp>
      <p:sp>
        <p:nvSpPr>
          <p:cNvPr id="11" name="Rettangolo 10"/>
          <p:cNvSpPr/>
          <p:nvPr/>
        </p:nvSpPr>
        <p:spPr>
          <a:xfrm>
            <a:off x="1440216" y="4999429"/>
            <a:ext cx="673559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1 </a:t>
            </a:r>
            <a:r>
              <a:rPr lang="it-IT" dirty="0" err="1" smtClean="0"/>
              <a:t>Fruit</a:t>
            </a:r>
            <a:r>
              <a:rPr lang="it-IT" dirty="0" smtClean="0"/>
              <a:t> </a:t>
            </a:r>
            <a:r>
              <a:rPr lang="it-IT" dirty="0" err="1"/>
              <a:t>m</a:t>
            </a:r>
            <a:r>
              <a:rPr lang="it-IT" dirty="0" err="1" smtClean="0"/>
              <a:t>orphological</a:t>
            </a:r>
            <a:r>
              <a:rPr lang="it-IT" dirty="0" smtClean="0"/>
              <a:t> </a:t>
            </a:r>
            <a:r>
              <a:rPr lang="it-IT" dirty="0" err="1" smtClean="0"/>
              <a:t>characteristics</a:t>
            </a:r>
            <a:r>
              <a:rPr lang="it-IT" smtClean="0"/>
              <a:t>: </a:t>
            </a:r>
            <a:r>
              <a:rPr lang="it-IT" dirty="0" smtClean="0"/>
              <a:t>a) San Marzano b)Vesuviano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86319789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20</Words>
  <Application>Microsoft Macintosh PowerPoint</Application>
  <PresentationFormat>Presentazione su schermo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Mara</dc:creator>
  <cp:lastModifiedBy>Mara</cp:lastModifiedBy>
  <cp:revision>4</cp:revision>
  <dcterms:created xsi:type="dcterms:W3CDTF">2013-11-28T14:38:28Z</dcterms:created>
  <dcterms:modified xsi:type="dcterms:W3CDTF">2013-11-28T15:21:35Z</dcterms:modified>
</cp:coreProperties>
</file>